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7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39" autoAdjust="0"/>
    <p:restoredTop sz="75350" autoAdjust="0"/>
  </p:normalViewPr>
  <p:slideViewPr>
    <p:cSldViewPr snapToGrid="0">
      <p:cViewPr varScale="1">
        <p:scale>
          <a:sx n="69" d="100"/>
          <a:sy n="69" d="100"/>
        </p:scale>
        <p:origin x="113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Hoja_de_c_lculo_de_Microsoft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Hoja_de_c_lculo_de_Microsoft_Excel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Hoja_de_c_lculo_de_Microsoft_Excel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∆K</a:t>
            </a:r>
            <a:endParaRPr lang="en-US" dirty="0"/>
          </a:p>
        </c:rich>
      </c:tx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estimated_ln_prob_data21.10!$J$2</c:f>
              <c:strCache>
                <c:ptCount val="1"/>
                <c:pt idx="0">
                  <c:v>Delta K</c:v>
                </c:pt>
              </c:strCache>
            </c:strRef>
          </c:tx>
          <c:marker>
            <c:symbol val="none"/>
          </c:marker>
          <c:cat>
            <c:numRef>
              <c:f>estimated_ln_prob_data21.10!$D$5:$D$12</c:f>
              <c:numCache>
                <c:formatCode>General</c:formatCode>
                <c:ptCount val="8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7</c:v>
                </c:pt>
                <c:pt idx="5">
                  <c:v>8</c:v>
                </c:pt>
                <c:pt idx="6">
                  <c:v>9</c:v>
                </c:pt>
                <c:pt idx="7">
                  <c:v>10</c:v>
                </c:pt>
              </c:numCache>
            </c:numRef>
          </c:cat>
          <c:val>
            <c:numRef>
              <c:f>estimated_ln_prob_data21.10!$J$5:$J$12</c:f>
              <c:numCache>
                <c:formatCode>General</c:formatCode>
                <c:ptCount val="8"/>
                <c:pt idx="0">
                  <c:v>4.6366198159999996</c:v>
                </c:pt>
                <c:pt idx="1">
                  <c:v>0.38625874700000001</c:v>
                </c:pt>
                <c:pt idx="2">
                  <c:v>1.8195832380000001</c:v>
                </c:pt>
                <c:pt idx="3">
                  <c:v>0.57394550300000002</c:v>
                </c:pt>
                <c:pt idx="4">
                  <c:v>1.515603566</c:v>
                </c:pt>
                <c:pt idx="5">
                  <c:v>0.41923407800000001</c:v>
                </c:pt>
                <c:pt idx="6">
                  <c:v>0.43111462699999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181037760"/>
        <c:axId val="1181038320"/>
      </c:lineChart>
      <c:catAx>
        <c:axId val="1181037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81038320"/>
        <c:crosses val="autoZero"/>
        <c:auto val="1"/>
        <c:lblAlgn val="ctr"/>
        <c:lblOffset val="100"/>
        <c:noMultiLvlLbl val="0"/>
      </c:catAx>
      <c:valAx>
        <c:axId val="1181038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81037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estimated_ln_prob_data21.10!$E$2</c:f>
              <c:strCache>
                <c:ptCount val="1"/>
                <c:pt idx="0">
                  <c:v>L(K)</c:v>
                </c:pt>
              </c:strCache>
            </c:strRef>
          </c:tx>
          <c:spPr>
            <a:ln w="28575">
              <a:noFill/>
            </a:ln>
          </c:spPr>
          <c:errBars>
            <c:errDir val="y"/>
            <c:errBarType val="both"/>
            <c:errValType val="cust"/>
            <c:noEndCap val="0"/>
            <c:plus>
              <c:numRef>
                <c:f>estimated_ln_prob_data21.10!$F$3:$F$12</c:f>
                <c:numCache>
                  <c:formatCode>General</c:formatCode>
                  <c:ptCount val="10"/>
                  <c:pt idx="0">
                    <c:v>9.5145318000000006E-2</c:v>
                  </c:pt>
                  <c:pt idx="1">
                    <c:v>0.23813972</c:v>
                  </c:pt>
                  <c:pt idx="2">
                    <c:v>176.2134987</c:v>
                  </c:pt>
                  <c:pt idx="3">
                    <c:v>2498.9984220000001</c:v>
                  </c:pt>
                  <c:pt idx="4">
                    <c:v>607.50724520000006</c:v>
                  </c:pt>
                  <c:pt idx="5">
                    <c:v>334.7356135</c:v>
                  </c:pt>
                  <c:pt idx="6">
                    <c:v>181.41947289999999</c:v>
                  </c:pt>
                  <c:pt idx="7">
                    <c:v>449.42672779999998</c:v>
                  </c:pt>
                  <c:pt idx="8">
                    <c:v>825.84764580000001</c:v>
                  </c:pt>
                  <c:pt idx="9">
                    <c:v>71.097423710000001</c:v>
                  </c:pt>
                </c:numCache>
              </c:numRef>
            </c:plus>
            <c:minus>
              <c:numRef>
                <c:f>estimated_ln_prob_data21.10!$F$3:$F$12</c:f>
                <c:numCache>
                  <c:formatCode>General</c:formatCode>
                  <c:ptCount val="10"/>
                  <c:pt idx="0">
                    <c:v>9.5145318000000006E-2</c:v>
                  </c:pt>
                  <c:pt idx="1">
                    <c:v>0.23813972</c:v>
                  </c:pt>
                  <c:pt idx="2">
                    <c:v>176.2134987</c:v>
                  </c:pt>
                  <c:pt idx="3">
                    <c:v>2498.9984220000001</c:v>
                  </c:pt>
                  <c:pt idx="4">
                    <c:v>607.50724520000006</c:v>
                  </c:pt>
                  <c:pt idx="5">
                    <c:v>334.7356135</c:v>
                  </c:pt>
                  <c:pt idx="6">
                    <c:v>181.41947289999999</c:v>
                  </c:pt>
                  <c:pt idx="7">
                    <c:v>449.42672779999998</c:v>
                  </c:pt>
                  <c:pt idx="8">
                    <c:v>825.84764580000001</c:v>
                  </c:pt>
                  <c:pt idx="9">
                    <c:v>71.097423710000001</c:v>
                  </c:pt>
                </c:numCache>
              </c:numRef>
            </c:minus>
          </c:errBars>
          <c:xVal>
            <c:numRef>
              <c:f>estimated_ln_prob_data21.10!$D$4:$D$12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numCache>
            </c:numRef>
          </c:xVal>
          <c:yVal>
            <c:numRef>
              <c:f>estimated_ln_prob_data21.10!$E$4:$E$12</c:f>
              <c:numCache>
                <c:formatCode>General</c:formatCode>
                <c:ptCount val="9"/>
                <c:pt idx="0">
                  <c:v>-27505.025000000001</c:v>
                </c:pt>
                <c:pt idx="1">
                  <c:v>-25576.235000000001</c:v>
                </c:pt>
                <c:pt idx="2">
                  <c:v>-24464.48</c:v>
                </c:pt>
                <c:pt idx="3">
                  <c:v>-22387.465</c:v>
                </c:pt>
                <c:pt idx="4">
                  <c:v>-21415.86</c:v>
                </c:pt>
                <c:pt idx="5">
                  <c:v>-20636.375</c:v>
                </c:pt>
                <c:pt idx="6">
                  <c:v>-20131.849999999999</c:v>
                </c:pt>
                <c:pt idx="7">
                  <c:v>-19815.740000000002</c:v>
                </c:pt>
                <c:pt idx="8">
                  <c:v>-19143.595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86464240"/>
        <c:axId val="786464800"/>
      </c:scatterChart>
      <c:valAx>
        <c:axId val="7864642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786464800"/>
        <c:crosses val="autoZero"/>
        <c:crossBetween val="midCat"/>
      </c:valAx>
      <c:valAx>
        <c:axId val="786464800"/>
        <c:scaling>
          <c:orientation val="minMax"/>
          <c:max val="-18000"/>
        </c:scaling>
        <c:delete val="0"/>
        <c:axPos val="l"/>
        <c:numFmt formatCode="General" sourceLinked="1"/>
        <c:majorTickMark val="out"/>
        <c:minorTickMark val="none"/>
        <c:tickLblPos val="nextTo"/>
        <c:crossAx val="786464240"/>
        <c:crosses val="autoZero"/>
        <c:crossBetween val="midCat"/>
        <c:majorUnit val="2000"/>
        <c:minorUnit val="10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∆K</a:t>
            </a:r>
            <a:endParaRPr lang="en-US" dirty="0"/>
          </a:p>
        </c:rich>
      </c:tx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estimated_ln_prob_data21.10!$J$2</c:f>
              <c:strCache>
                <c:ptCount val="1"/>
                <c:pt idx="0">
                  <c:v>Delta K</c:v>
                </c:pt>
              </c:strCache>
            </c:strRef>
          </c:tx>
          <c:marker>
            <c:symbol val="none"/>
          </c:marker>
          <c:cat>
            <c:numRef>
              <c:f>estimated_ln_prob_data21.10!$D$4:$D$12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</c:numCache>
            </c:numRef>
          </c:cat>
          <c:val>
            <c:numRef>
              <c:f>estimated_ln_prob_data21.10!$J$4:$J$12</c:f>
              <c:numCache>
                <c:formatCode>General</c:formatCode>
                <c:ptCount val="9"/>
                <c:pt idx="0">
                  <c:v>49457.541109999998</c:v>
                </c:pt>
                <c:pt idx="1">
                  <c:v>4.6366198159999996</c:v>
                </c:pt>
                <c:pt idx="2">
                  <c:v>0.38625874700000001</c:v>
                </c:pt>
                <c:pt idx="3">
                  <c:v>1.8195832380000001</c:v>
                </c:pt>
                <c:pt idx="4">
                  <c:v>0.57394550300000002</c:v>
                </c:pt>
                <c:pt idx="5">
                  <c:v>1.515603566</c:v>
                </c:pt>
                <c:pt idx="6">
                  <c:v>0.41923407800000001</c:v>
                </c:pt>
                <c:pt idx="7">
                  <c:v>0.43111462699999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00816752"/>
        <c:axId val="100817312"/>
      </c:lineChart>
      <c:catAx>
        <c:axId val="100816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00817312"/>
        <c:crosses val="autoZero"/>
        <c:auto val="1"/>
        <c:lblAlgn val="ctr"/>
        <c:lblOffset val="100"/>
        <c:noMultiLvlLbl val="0"/>
      </c:catAx>
      <c:valAx>
        <c:axId val="100817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00816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ACCC0A-5CA4-4578-86F2-154DB1B05269}" type="datetimeFigureOut">
              <a:rPr lang="it-IT" smtClean="0"/>
              <a:t>11/02/201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B1B0EF-04D7-4DBA-B85A-1E25B58C139F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0265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B1B0EF-04D7-4DBA-B85A-1E25B58C139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41278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0533D7-415E-44FE-8172-D4FAA7E0D6EE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1953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E0862-C5CF-4B81-87F3-7D243E9C7CDF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978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D210E9-5973-4BF7-B1C1-7A72B11C5863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3020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3D2BC-C278-44D4-A77E-193C73872FF6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2782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915D6-7D6A-4C9C-B1BC-7459E8CA01D2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7652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2B76A-A962-4A23-A01C-D060AD670454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6068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092001-56CE-46FA-9606-8124B396AFE3}" type="datetime1">
              <a:rPr lang="it-IT" smtClean="0"/>
              <a:t>11/0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15044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EE333-AEDB-4676-95C2-C316ED8D171F}" type="datetime1">
              <a:rPr lang="it-IT" smtClean="0"/>
              <a:t>11/02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1099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430CC-BD11-49FF-B8B0-0604DEE46240}" type="datetime1">
              <a:rPr lang="it-IT" smtClean="0"/>
              <a:t>11/02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2202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2A85E-6E44-460A-B9A3-F956AA119918}" type="datetime1">
              <a:rPr lang="it-IT" smtClean="0"/>
              <a:t>11/02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3683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35FBE4-DDF7-42C1-82A1-ED29F6565197}" type="datetime1">
              <a:rPr lang="it-IT" smtClean="0"/>
              <a:t>11/0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2432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E963AD-547D-426E-8342-F9FE9B7D6F63}" type="datetime1">
              <a:rPr lang="it-IT" smtClean="0"/>
              <a:t>11/02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60634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47C40-46D3-4064-AFDD-0B3A939F131B}" type="datetime1">
              <a:rPr lang="it-IT" smtClean="0"/>
              <a:t>11/02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E9CA7-64A6-4454-9649-00D2AFD689AC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8444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amonforte@ibmcp.upv.es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hyperlink" Target="mailto:mpicosi@btc.upv.es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0" y="0"/>
            <a:ext cx="11901488" cy="5201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riability of candidate genes, genetic structure and association with sugar accumulation and climacteric behavior in a broad </a:t>
            </a:r>
            <a:r>
              <a:rPr lang="en-US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rmplasm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llection of melons (</a:t>
            </a:r>
            <a:r>
              <a:rPr lang="en-US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cumis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lo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.).</a:t>
            </a:r>
            <a:endParaRPr lang="en-US" sz="1400" b="1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id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.1, Moser C.1,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eras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.2,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lpice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.3,4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unn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J.E.3;de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ngen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F.5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forte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. J.6 and </a:t>
            </a:r>
            <a:r>
              <a:rPr lang="en-US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có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2</a:t>
            </a:r>
          </a:p>
          <a:p>
            <a:pPr>
              <a:spcAft>
                <a:spcPts val="800"/>
              </a:spcAft>
            </a:pPr>
            <a:r>
              <a:rPr lang="en-US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filiations</a:t>
            </a:r>
            <a:endParaRPr lang="it-IT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GB" sz="11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GB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earch 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Innovation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ept. Genomics and Biology of Fruit Crops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ndazion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dmund Mach (FEM), Via E. Mach 1, 38010 San Michele a/A, Italy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GB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e for the Conservation and Breeding of Agricultural Biodiversity (COMAV-UPV),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at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litècnica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 Valencia, Camino de Vera s/n, 46022 Valencia, Spain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GB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x-Planck-Institute of Molecular Plant Physiology,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ssenschaftspark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olm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m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ühlenberg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, 14476 Potsdam (OT)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olm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Germany. </a:t>
            </a:r>
            <a:endParaRPr lang="en-GB" sz="1100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lant Systems Biology Research Laboratory, Department of Botany and Plant Science, Plant and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riBioscienc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search Centre, National University of Galway, University Road, Galway, Ireland</a:t>
            </a:r>
            <a:endParaRPr lang="en-GB" sz="1100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s-ES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MCLAUSE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usiness Unit of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magrai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Station de Mas Saint Pierre, La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lin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13210 Saint-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émy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e-Provence, France.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it-IT" sz="11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it-IT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o de Biología Molecular y Celular de Plantas (IBMCP), Universitat Politècnica de València (UPV)-Consejo Superior de Investigaciones Científicas (CSIC), Ciudad Politécnica de la Innovación (CPI), Ed. 8E, C/</a:t>
            </a:r>
            <a:r>
              <a:rPr lang="it-IT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geniero</a:t>
            </a:r>
            <a:r>
              <a:rPr lang="it-IT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austo Elio s/n, 46022 Valencia, </a:t>
            </a:r>
            <a:r>
              <a:rPr lang="it-IT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ain</a:t>
            </a:r>
            <a:r>
              <a:rPr lang="it-IT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it-IT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100" u="sng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</a:t>
            </a:r>
            <a:r>
              <a:rPr lang="en-US" sz="1100" u="sng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uthors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J.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fort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u="sng" dirty="0">
                <a:solidFill>
                  <a:srgbClr val="0563C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amonforte@ibmcp.upv.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endParaRPr lang="it-IT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có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u="sng" dirty="0">
                <a:solidFill>
                  <a:srgbClr val="0563C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mpicosi@btc.upv.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endParaRPr lang="en-US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endParaRPr lang="en-US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</a:pP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Estimated number of clusters obtained with STRUCTURE for K values from 1 to 10 using SNPs data for the all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rmplasm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lection</a:t>
            </a:r>
            <a:r>
              <a:rPr lang="en-US" sz="11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Graphical representation of estimated mean L (k) and b) its derivative statistics ∆K. The graph below was obtained excluding k=2 in order to evidence the subpopulations present in t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rmplasm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c) Table summarizing parameters of STRUCTURE simulations performed for each present K: mean likelihoods of models, their standard deviations, ∆K</a:t>
            </a:r>
            <a:endParaRPr lang="it-IT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92512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"/>
          <p:cNvGraphicFramePr>
            <a:graphicFrameLocks/>
          </p:cNvGraphicFramePr>
          <p:nvPr>
            <p:extLst/>
          </p:nvPr>
        </p:nvGraphicFramePr>
        <p:xfrm>
          <a:off x="6456571" y="3452071"/>
          <a:ext cx="4308763" cy="26081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Tabella 5"/>
          <p:cNvGraphicFramePr>
            <a:graphicFrameLocks noGrp="1"/>
          </p:cNvGraphicFramePr>
          <p:nvPr>
            <p:extLst/>
          </p:nvPr>
        </p:nvGraphicFramePr>
        <p:xfrm>
          <a:off x="1429815" y="3917377"/>
          <a:ext cx="4292600" cy="2082165"/>
        </p:xfrm>
        <a:graphic>
          <a:graphicData uri="http://schemas.openxmlformats.org/drawingml/2006/table">
            <a:tbl>
              <a:tblPr/>
              <a:tblGrid>
                <a:gridCol w="609600"/>
                <a:gridCol w="609600"/>
                <a:gridCol w="609600"/>
                <a:gridCol w="609600"/>
                <a:gridCol w="609600"/>
                <a:gridCol w="609600"/>
                <a:gridCol w="635000"/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K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L(K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STDEV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L'(K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L"(K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[L"K]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</a:rPr>
                        <a:t>∆K</a:t>
                      </a:r>
                      <a:endParaRPr lang="it-IT" sz="11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64A2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1211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5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5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8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706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777.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77.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457.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576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6.21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8.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817.0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7.0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36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464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98.9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1.7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5.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5.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62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387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7.50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77.0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05.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05.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95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415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4.73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1.6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2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39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636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1.41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9.4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4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4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156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131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9.42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4.5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8.4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.4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92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815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5.84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6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6.0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6.0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11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9143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.097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2.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672.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2.1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8064A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12" name="Gruppo 11"/>
          <p:cNvGrpSpPr/>
          <p:nvPr/>
        </p:nvGrpSpPr>
        <p:grpSpPr>
          <a:xfrm>
            <a:off x="555265" y="896318"/>
            <a:ext cx="10129021" cy="2743200"/>
            <a:chOff x="542441" y="123282"/>
            <a:chExt cx="10129021" cy="2743200"/>
          </a:xfrm>
        </p:grpSpPr>
        <p:graphicFrame>
          <p:nvGraphicFramePr>
            <p:cNvPr id="8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64867846"/>
                </p:ext>
              </p:extLst>
            </p:nvPr>
          </p:nvGraphicFramePr>
          <p:xfrm>
            <a:off x="894367" y="123282"/>
            <a:ext cx="459105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" name="CasellaDiTesto 2"/>
            <p:cNvSpPr txBox="1"/>
            <p:nvPr/>
          </p:nvSpPr>
          <p:spPr>
            <a:xfrm>
              <a:off x="542441" y="588936"/>
              <a:ext cx="3658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 smtClean="0"/>
                <a:t>a)</a:t>
              </a:r>
              <a:endParaRPr lang="it-IT" dirty="0"/>
            </a:p>
          </p:txBody>
        </p:sp>
        <p:graphicFrame>
          <p:nvGraphicFramePr>
            <p:cNvPr id="7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99777048"/>
                </p:ext>
              </p:extLst>
            </p:nvPr>
          </p:nvGraphicFramePr>
          <p:xfrm>
            <a:off x="6303817" y="130341"/>
            <a:ext cx="4367645" cy="26336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" name="CasellaDiTesto 8"/>
            <p:cNvSpPr txBox="1"/>
            <p:nvPr/>
          </p:nvSpPr>
          <p:spPr>
            <a:xfrm>
              <a:off x="5840279" y="588936"/>
              <a:ext cx="377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b</a:t>
              </a:r>
              <a:r>
                <a:rPr lang="it-IT" dirty="0" smtClean="0"/>
                <a:t>)</a:t>
              </a:r>
              <a:endParaRPr lang="it-IT" dirty="0"/>
            </a:p>
          </p:txBody>
        </p:sp>
      </p:grpSp>
      <p:sp>
        <p:nvSpPr>
          <p:cNvPr id="10" name="CasellaDiTesto 9"/>
          <p:cNvSpPr txBox="1"/>
          <p:nvPr/>
        </p:nvSpPr>
        <p:spPr>
          <a:xfrm>
            <a:off x="555265" y="3639518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c)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420699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7</TotalTime>
  <Words>351</Words>
  <Application>Microsoft Office PowerPoint</Application>
  <PresentationFormat>Panorámica</PresentationFormat>
  <Paragraphs>100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ción de PowerPoint</vt:lpstr>
      <vt:lpstr>Presentación de PowerPoint</vt:lpstr>
    </vt:vector>
  </TitlesOfParts>
  <Company>FE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rmen leida</dc:creator>
  <cp:lastModifiedBy>Usuario</cp:lastModifiedBy>
  <cp:revision>9</cp:revision>
  <dcterms:created xsi:type="dcterms:W3CDTF">2014-05-13T09:00:27Z</dcterms:created>
  <dcterms:modified xsi:type="dcterms:W3CDTF">2015-02-11T15:13:35Z</dcterms:modified>
</cp:coreProperties>
</file>